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5" d="100"/>
          <a:sy n="75" d="100"/>
        </p:scale>
        <p:origin x="874" y="4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6E2107B-9242-2183-B8C8-799D1AC4505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6317A63-B638-D1B3-9F6F-EFD9CFF8696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79567B1-C92B-75B6-ABB2-E9149BAA08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07C278-C76B-47D7-B487-9BA2910BC9D4}" type="datetimeFigureOut">
              <a:rPr lang="en-CA" smtClean="0"/>
              <a:t>2024-01-15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728567B-36FE-F894-9CB5-D7D71886A7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995626C-328F-A058-2BCB-C607D61754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22EE40-D04B-4B7E-937A-C462B4F06EC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14629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E55B44D-1B27-AD90-2614-379E2155B9B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B3F4BB1-CC3C-251D-3E21-CF64844BB03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A62BE52-152B-D1F4-FA1A-03FABDFFDD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07C278-C76B-47D7-B487-9BA2910BC9D4}" type="datetimeFigureOut">
              <a:rPr lang="en-CA" smtClean="0"/>
              <a:t>2024-01-15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AD804F4-D1D1-CE28-0964-825C215A8B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CD920CC-57FA-572C-89A4-FF40470593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22EE40-D04B-4B7E-937A-C462B4F06EC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9607838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ECE3C42-FE28-42DA-331E-F7603B46614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09D1D7E-05B1-A248-BEA1-52BBF42DCA0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AF58813-80AA-FF12-24DA-C0EC35D0FC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07C278-C76B-47D7-B487-9BA2910BC9D4}" type="datetimeFigureOut">
              <a:rPr lang="en-CA" smtClean="0"/>
              <a:t>2024-01-15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358B99A-8E0C-2C60-83D0-80F5254025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42FC4DD-94B1-A5C2-305B-5DC85E5CFC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22EE40-D04B-4B7E-937A-C462B4F06EC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9446227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D85A9A6-241D-32AD-D866-EE3BBBDD6C3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AC00BE6-498C-6A99-41AF-FE0122987E0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BCFD3BC-B8AB-A9A7-C7D0-52E7586E2D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07C278-C76B-47D7-B487-9BA2910BC9D4}" type="datetimeFigureOut">
              <a:rPr lang="en-CA" smtClean="0"/>
              <a:t>2024-01-15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9899415-E80F-4402-373A-61C3D891FF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824DEFB-772E-295C-2269-2938899E41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22EE40-D04B-4B7E-937A-C462B4F06EC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118976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ACE4BDC-02E2-3878-3AAB-685F58D5248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2D0975D-72F0-1143-6997-8BB1AF407A4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377B156-B5EE-91C1-2EE2-2F8485210E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07C278-C76B-47D7-B487-9BA2910BC9D4}" type="datetimeFigureOut">
              <a:rPr lang="en-CA" smtClean="0"/>
              <a:t>2024-01-15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06539C5-9C7A-E485-9BCB-D238122DEB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D06CD53-AD27-A508-B38F-A3A3133948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22EE40-D04B-4B7E-937A-C462B4F06EC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3282024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770ACE5-D905-30DB-F6CD-0E9F73E3E73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11276EF-E846-2EF2-462F-D72F3F33131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1D497EF-73F8-666B-6551-5CAC0D34C50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4503381-3E31-D63D-4A57-218F1E41A2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07C278-C76B-47D7-B487-9BA2910BC9D4}" type="datetimeFigureOut">
              <a:rPr lang="en-CA" smtClean="0"/>
              <a:t>2024-01-15</a:t>
            </a:fld>
            <a:endParaRPr lang="en-C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B3A99BE-D0B2-00CD-9B3C-32AAF919AA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14D99FB-2E8E-4D55-5AE4-35470FEE6E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22EE40-D04B-4B7E-937A-C462B4F06EC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3828057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88B36FC-A992-D100-C735-C0C8BDE7F9E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515779A-FEFE-9408-2423-D1E22B5E1E2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0C23305-54AD-A307-ACAB-088336A860A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E2E9230-0C93-7ABA-C7EA-D599EC51DC2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579AD31-7D43-EBE7-8399-742C45D4D0C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399506C-5410-B404-A693-DE17315C42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07C278-C76B-47D7-B487-9BA2910BC9D4}" type="datetimeFigureOut">
              <a:rPr lang="en-CA" smtClean="0"/>
              <a:t>2024-01-15</a:t>
            </a:fld>
            <a:endParaRPr lang="en-CA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25516F2-B03C-8D96-E3FC-856F551597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897EEE6-FBA8-C490-5A47-7DDBC3CCB9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22EE40-D04B-4B7E-937A-C462B4F06EC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6879153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0C0342C-ECFB-F7EF-614F-42EA3752D40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52F49F7-59EC-C048-B3D2-920B62B283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07C278-C76B-47D7-B487-9BA2910BC9D4}" type="datetimeFigureOut">
              <a:rPr lang="en-CA" smtClean="0"/>
              <a:t>2024-01-15</a:t>
            </a:fld>
            <a:endParaRPr lang="en-CA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9141E5C-65A1-9106-5F27-6965D6478A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93AAC02-7555-F862-8E8A-C1113B0CFD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22EE40-D04B-4B7E-937A-C462B4F06EC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4424643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26B969C-7938-73A7-342F-868C33216C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07C278-C76B-47D7-B487-9BA2910BC9D4}" type="datetimeFigureOut">
              <a:rPr lang="en-CA" smtClean="0"/>
              <a:t>2024-01-15</a:t>
            </a:fld>
            <a:endParaRPr lang="en-CA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0638EE2-6E7B-6960-6B78-FD045793B8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6487F3D-EEAE-C7DB-DB53-AE97635471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22EE40-D04B-4B7E-937A-C462B4F06EC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9401005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CA839BF-D9F1-1D7D-B914-0CDA8DD0F2A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2DA544D-6724-64D7-79A6-257720EAA08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75B9E26-9A64-DCA7-18F4-2A02BF8EE20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997EE25-0BDE-68F8-623C-59478357C0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07C278-C76B-47D7-B487-9BA2910BC9D4}" type="datetimeFigureOut">
              <a:rPr lang="en-CA" smtClean="0"/>
              <a:t>2024-01-15</a:t>
            </a:fld>
            <a:endParaRPr lang="en-C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1A438BB-5B15-A737-D704-4C9F6F1F35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451C66D-6B42-B386-B2D2-30302042BA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22EE40-D04B-4B7E-937A-C462B4F06EC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9804551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FB4A6F-0212-EE73-9958-9E3AE557B93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2439FE4-10B0-2F72-155C-412C23F69E3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A719999-DF21-EE33-8F66-8CD15D989A6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B35B79D-C2E2-40C1-1A2D-11FD0888C2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07C278-C76B-47D7-B487-9BA2910BC9D4}" type="datetimeFigureOut">
              <a:rPr lang="en-CA" smtClean="0"/>
              <a:t>2024-01-15</a:t>
            </a:fld>
            <a:endParaRPr lang="en-C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8A671F1-7CD9-62C5-C484-89E1495BBA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11783C6-E8A8-6C3C-588D-FB26A6AB4F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22EE40-D04B-4B7E-937A-C462B4F06EC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3898239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2BE7EFD-A40E-DAB3-041B-71AAE87CE27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2AAEC97-BAD6-0D46-3797-0CEBCF760F5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4A4B616-9A01-B6CC-4811-666F6130B04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07C278-C76B-47D7-B487-9BA2910BC9D4}" type="datetimeFigureOut">
              <a:rPr lang="en-CA" smtClean="0"/>
              <a:t>2024-01-15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857106B-4739-D1D6-6D43-8239AF79599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E16FB41-EB77-2227-8221-5B0618CCA71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222EE40-D04B-4B7E-937A-C462B4F06EC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7141874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33BE65A3-66D1-BB0B-7657-29EAED05499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01349" y="50800"/>
            <a:ext cx="6789301" cy="616712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79972A64-3979-484A-1A56-087FF67465E9}"/>
              </a:ext>
            </a:extLst>
          </p:cNvPr>
          <p:cNvSpPr txBox="1"/>
          <p:nvPr/>
        </p:nvSpPr>
        <p:spPr>
          <a:xfrm>
            <a:off x="1953163" y="6283980"/>
            <a:ext cx="828567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ox plot distributions showing variations in the studied plant protein solubility, emulsifying activity index, emulsifying capacity, and gel strength</a:t>
            </a:r>
            <a:endParaRPr 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430972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25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ONIT MANDAL</dc:creator>
  <cp:lastModifiedBy>RONIT MANDAL</cp:lastModifiedBy>
  <cp:revision>1</cp:revision>
  <dcterms:created xsi:type="dcterms:W3CDTF">2024-01-15T17:34:08Z</dcterms:created>
  <dcterms:modified xsi:type="dcterms:W3CDTF">2024-01-15T17:36:06Z</dcterms:modified>
</cp:coreProperties>
</file>